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 showGuides="1">
      <p:cViewPr varScale="1">
        <p:scale>
          <a:sx n="56" d="100"/>
          <a:sy n="56" d="100"/>
        </p:scale>
        <p:origin x="-2400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ack%20Up%20Shelby:Users:montagues:Documents:Baker%20Lab:MB%20Mini-Olympiad:MBScreen_Analysis_21May2015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Back%20Up%20Shelby:Users:montagues:Documents:Baker%20Lab:MB%20Mini-Olympiad:MBScreen_Analysis_28Apr201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2577527333998"/>
          <c:y val="0.0589167104705807"/>
          <c:w val="0.791462041000225"/>
          <c:h val="0.723633523072976"/>
        </c:manualLayout>
      </c:layout>
      <c:barChart>
        <c:barDir val="col"/>
        <c:grouping val="clustered"/>
        <c:varyColors val="0"/>
        <c:ser>
          <c:idx val="0"/>
          <c:order val="0"/>
          <c:tx>
            <c:v>CIbegin</c:v>
          </c:tx>
          <c:spPr>
            <a:solidFill>
              <a:srgbClr val="FF0000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NewSort_20May15!$K$91:$K$97</c:f>
                <c:numCache>
                  <c:formatCode>General</c:formatCode>
                  <c:ptCount val="7"/>
                  <c:pt idx="0">
                    <c:v>0.0744277068853326</c:v>
                  </c:pt>
                  <c:pt idx="1">
                    <c:v>0.0723108296362877</c:v>
                  </c:pt>
                  <c:pt idx="2">
                    <c:v>0.0752416427258191</c:v>
                  </c:pt>
                  <c:pt idx="4">
                    <c:v>0.0663416127924378</c:v>
                  </c:pt>
                  <c:pt idx="5">
                    <c:v>0.0461537360632078</c:v>
                  </c:pt>
                  <c:pt idx="6">
                    <c:v>0.05185813178560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ort_20May15!$F$91:$F$97</c:f>
              <c:strCache>
                <c:ptCount val="7"/>
                <c:pt idx="0">
                  <c:v>MB021B</c:v>
                </c:pt>
                <c:pt idx="1">
                  <c:v>MB022B</c:v>
                </c:pt>
                <c:pt idx="2">
                  <c:v>MB113C</c:v>
                </c:pt>
                <c:pt idx="4">
                  <c:v>MB465C</c:v>
                </c:pt>
                <c:pt idx="5">
                  <c:v>MB380B</c:v>
                </c:pt>
                <c:pt idx="6">
                  <c:v>MB013B</c:v>
                </c:pt>
              </c:strCache>
            </c:strRef>
          </c:cat>
          <c:val>
            <c:numRef>
              <c:f>NewSort_20May15!$G$91:$G$97</c:f>
              <c:numCache>
                <c:formatCode>General</c:formatCode>
                <c:ptCount val="7"/>
                <c:pt idx="0">
                  <c:v>0.500625</c:v>
                </c:pt>
                <c:pt idx="1">
                  <c:v>0.45958625</c:v>
                </c:pt>
                <c:pt idx="2">
                  <c:v>0.363144696969697</c:v>
                </c:pt>
                <c:pt idx="4">
                  <c:v>0.114485151515151</c:v>
                </c:pt>
                <c:pt idx="5">
                  <c:v>0.18417298245614</c:v>
                </c:pt>
                <c:pt idx="6">
                  <c:v>0.279038257575758</c:v>
                </c:pt>
              </c:numCache>
            </c:numRef>
          </c:val>
        </c:ser>
        <c:ser>
          <c:idx val="1"/>
          <c:order val="1"/>
          <c:tx>
            <c:v>CIend</c:v>
          </c:tx>
          <c:spPr>
            <a:solidFill>
              <a:srgbClr val="0000FF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NewSort_20May15!$L$91:$L$97</c:f>
                <c:numCache>
                  <c:formatCode>General</c:formatCode>
                  <c:ptCount val="7"/>
                  <c:pt idx="0">
                    <c:v>0.0412636532021393</c:v>
                  </c:pt>
                  <c:pt idx="1">
                    <c:v>0.0254127166107661</c:v>
                  </c:pt>
                  <c:pt idx="2">
                    <c:v>0.0760420187131132</c:v>
                  </c:pt>
                  <c:pt idx="4">
                    <c:v>0.015879175469911</c:v>
                  </c:pt>
                  <c:pt idx="5">
                    <c:v>0.0333950567302961</c:v>
                  </c:pt>
                  <c:pt idx="6">
                    <c:v>0.042048104775557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ort_20May15!$F$91:$F$97</c:f>
              <c:strCache>
                <c:ptCount val="7"/>
                <c:pt idx="0">
                  <c:v>MB021B</c:v>
                </c:pt>
                <c:pt idx="1">
                  <c:v>MB022B</c:v>
                </c:pt>
                <c:pt idx="2">
                  <c:v>MB113C</c:v>
                </c:pt>
                <c:pt idx="4">
                  <c:v>MB465C</c:v>
                </c:pt>
                <c:pt idx="5">
                  <c:v>MB380B</c:v>
                </c:pt>
                <c:pt idx="6">
                  <c:v>MB013B</c:v>
                </c:pt>
              </c:strCache>
            </c:strRef>
          </c:cat>
          <c:val>
            <c:numRef>
              <c:f>NewSort_20May15!$H$91:$H$97</c:f>
              <c:numCache>
                <c:formatCode>General</c:formatCode>
                <c:ptCount val="7"/>
                <c:pt idx="0">
                  <c:v>0.0843894444444444</c:v>
                </c:pt>
                <c:pt idx="1">
                  <c:v>0.0504979166666667</c:v>
                </c:pt>
                <c:pt idx="2">
                  <c:v>0.279902424242424</c:v>
                </c:pt>
                <c:pt idx="4">
                  <c:v>0.0199640909090909</c:v>
                </c:pt>
                <c:pt idx="5">
                  <c:v>0.0379544736842105</c:v>
                </c:pt>
                <c:pt idx="6">
                  <c:v>0.0787938636363636</c:v>
                </c:pt>
              </c:numCache>
            </c:numRef>
          </c:val>
        </c:ser>
        <c:ser>
          <c:idx val="2"/>
          <c:order val="2"/>
          <c:tx>
            <c:v>CItest</c:v>
          </c:tx>
          <c:spPr>
            <a:solidFill>
              <a:srgbClr val="FFFF00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NewSort_20May15!$M$91:$M$97</c:f>
                <c:numCache>
                  <c:formatCode>General</c:formatCode>
                  <c:ptCount val="7"/>
                  <c:pt idx="0">
                    <c:v>0.0731844628805623</c:v>
                  </c:pt>
                  <c:pt idx="1">
                    <c:v>0.0664875408199543</c:v>
                  </c:pt>
                  <c:pt idx="2">
                    <c:v>0.086161861366601</c:v>
                  </c:pt>
                  <c:pt idx="4">
                    <c:v>0.0843227736646703</c:v>
                  </c:pt>
                  <c:pt idx="5">
                    <c:v>0.0819806264494704</c:v>
                  </c:pt>
                  <c:pt idx="6">
                    <c:v>0.07267783328719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ort_20May15!$F$91:$F$97</c:f>
              <c:strCache>
                <c:ptCount val="7"/>
                <c:pt idx="0">
                  <c:v>MB021B</c:v>
                </c:pt>
                <c:pt idx="1">
                  <c:v>MB022B</c:v>
                </c:pt>
                <c:pt idx="2">
                  <c:v>MB113C</c:v>
                </c:pt>
                <c:pt idx="4">
                  <c:v>MB465C</c:v>
                </c:pt>
                <c:pt idx="5">
                  <c:v>MB380B</c:v>
                </c:pt>
                <c:pt idx="6">
                  <c:v>MB013B</c:v>
                </c:pt>
              </c:strCache>
            </c:strRef>
          </c:cat>
          <c:val>
            <c:numRef>
              <c:f>NewSort_20May15!$I$91:$I$97</c:f>
              <c:numCache>
                <c:formatCode>General</c:formatCode>
                <c:ptCount val="7"/>
                <c:pt idx="0">
                  <c:v>0.463621666666667</c:v>
                </c:pt>
                <c:pt idx="1">
                  <c:v>0.2943405</c:v>
                </c:pt>
                <c:pt idx="2">
                  <c:v>0.363919242424242</c:v>
                </c:pt>
                <c:pt idx="4">
                  <c:v>0.181730909090909</c:v>
                </c:pt>
                <c:pt idx="5">
                  <c:v>0.324519385964912</c:v>
                </c:pt>
                <c:pt idx="6">
                  <c:v>0.27860181818181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88700072"/>
        <c:axId val="-2088696984"/>
      </c:barChart>
      <c:catAx>
        <c:axId val="-2088700072"/>
        <c:scaling>
          <c:orientation val="minMax"/>
        </c:scaling>
        <c:delete val="0"/>
        <c:axPos val="b"/>
        <c:majorTickMark val="out"/>
        <c:minorTickMark val="none"/>
        <c:tickLblPos val="low"/>
        <c:txPr>
          <a:bodyPr rot="-5400000" vert="horz"/>
          <a:lstStyle/>
          <a:p>
            <a:pPr>
              <a:defRPr/>
            </a:pPr>
            <a:endParaRPr lang="en-US"/>
          </a:p>
        </c:txPr>
        <c:crossAx val="-2088696984"/>
        <c:crosses val="autoZero"/>
        <c:auto val="1"/>
        <c:lblAlgn val="ctr"/>
        <c:lblOffset val="100"/>
        <c:noMultiLvlLbl val="0"/>
      </c:catAx>
      <c:valAx>
        <c:axId val="-20886969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ourtship index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8870007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76417927029104"/>
          <c:y val="0.0326347188930653"/>
          <c:w val="0.191479631041176"/>
          <c:h val="0.245858255173233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390385205268"/>
          <c:y val="0.0813734618025281"/>
          <c:w val="0.792548336186339"/>
          <c:h val="0.618293404806604"/>
        </c:manualLayout>
      </c:layout>
      <c:barChart>
        <c:barDir val="col"/>
        <c:grouping val="clustered"/>
        <c:varyColors val="0"/>
        <c:ser>
          <c:idx val="0"/>
          <c:order val="0"/>
          <c:tx>
            <c:v>LI</c:v>
          </c:tx>
          <c:spPr>
            <a:solidFill>
              <a:srgbClr val="660066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ortByPublishedOrder_12Jan!$S$91:$S$97</c:f>
                <c:numCache>
                  <c:formatCode>General</c:formatCode>
                  <c:ptCount val="7"/>
                  <c:pt idx="0">
                    <c:v>0.0678429430287389</c:v>
                  </c:pt>
                  <c:pt idx="1">
                    <c:v>0.0674768357621613</c:v>
                  </c:pt>
                  <c:pt idx="2">
                    <c:v>0.0592078829655435</c:v>
                  </c:pt>
                  <c:pt idx="4">
                    <c:v>0.067720485417005</c:v>
                  </c:pt>
                  <c:pt idx="5">
                    <c:v>0.0370998350834766</c:v>
                  </c:pt>
                  <c:pt idx="6">
                    <c:v>0.04811985635693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ortByPublishedOrder_12Jan!$O$91:$O$97</c:f>
              <c:strCache>
                <c:ptCount val="7"/>
                <c:pt idx="0">
                  <c:v>MB021B</c:v>
                </c:pt>
                <c:pt idx="1">
                  <c:v>MB022B</c:v>
                </c:pt>
                <c:pt idx="2">
                  <c:v>MB113C</c:v>
                </c:pt>
                <c:pt idx="4">
                  <c:v>MB465C</c:v>
                </c:pt>
                <c:pt idx="5">
                  <c:v>MB380B</c:v>
                </c:pt>
                <c:pt idx="6">
                  <c:v>MB013B</c:v>
                </c:pt>
              </c:strCache>
            </c:strRef>
          </c:cat>
          <c:val>
            <c:numRef>
              <c:f>SortByPublishedOrder_12Jan!$P$91:$P$97</c:f>
              <c:numCache>
                <c:formatCode>General</c:formatCode>
                <c:ptCount val="7"/>
                <c:pt idx="0">
                  <c:v>0.416235555555556</c:v>
                </c:pt>
                <c:pt idx="1">
                  <c:v>0.409088333333333</c:v>
                </c:pt>
                <c:pt idx="2">
                  <c:v>0.0832422727272727</c:v>
                </c:pt>
                <c:pt idx="4">
                  <c:v>0.0945210606060606</c:v>
                </c:pt>
                <c:pt idx="5">
                  <c:v>0.14621850877193</c:v>
                </c:pt>
                <c:pt idx="6">
                  <c:v>0.200244393939394</c:v>
                </c:pt>
              </c:numCache>
            </c:numRef>
          </c:val>
        </c:ser>
        <c:ser>
          <c:idx val="1"/>
          <c:order val="1"/>
          <c:tx>
            <c:v>MI</c:v>
          </c:tx>
          <c:spPr>
            <a:solidFill>
              <a:srgbClr val="008000"/>
            </a:solidFill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.0</c:v>
                </c:pt>
              </c:numLit>
            </c:plus>
            <c:minus>
              <c:numRef>
                <c:f>SortByPublishedOrder_12Jan!$T$91:$T$97</c:f>
                <c:numCache>
                  <c:formatCode>General</c:formatCode>
                  <c:ptCount val="7"/>
                  <c:pt idx="0">
                    <c:v>0.0895901405370379</c:v>
                  </c:pt>
                  <c:pt idx="1">
                    <c:v>0.0715199986193159</c:v>
                  </c:pt>
                  <c:pt idx="2">
                    <c:v>0.127611351187215</c:v>
                  </c:pt>
                  <c:pt idx="4">
                    <c:v>0.0887879295723818</c:v>
                  </c:pt>
                  <c:pt idx="5">
                    <c:v>0.0908002530841415</c:v>
                  </c:pt>
                  <c:pt idx="6">
                    <c:v>0.0867624147630959</c:v>
                  </c:pt>
                </c:numCache>
              </c:numRef>
            </c:minus>
          </c:errBars>
          <c:cat>
            <c:strRef>
              <c:f>SortByPublishedOrder_12Jan!$O$91:$O$97</c:f>
              <c:strCache>
                <c:ptCount val="7"/>
                <c:pt idx="0">
                  <c:v>MB021B</c:v>
                </c:pt>
                <c:pt idx="1">
                  <c:v>MB022B</c:v>
                </c:pt>
                <c:pt idx="2">
                  <c:v>MB113C</c:v>
                </c:pt>
                <c:pt idx="4">
                  <c:v>MB465C</c:v>
                </c:pt>
                <c:pt idx="5">
                  <c:v>MB380B</c:v>
                </c:pt>
                <c:pt idx="6">
                  <c:v>MB013B</c:v>
                </c:pt>
              </c:strCache>
            </c:strRef>
          </c:cat>
          <c:val>
            <c:numRef>
              <c:f>SortByPublishedOrder_12Jan!$Q$91:$Q$97</c:f>
              <c:numCache>
                <c:formatCode>General</c:formatCode>
                <c:ptCount val="7"/>
                <c:pt idx="0">
                  <c:v>-0.379232222222222</c:v>
                </c:pt>
                <c:pt idx="1">
                  <c:v>-0.243842583333333</c:v>
                </c:pt>
                <c:pt idx="2">
                  <c:v>-0.0840168181818182</c:v>
                </c:pt>
                <c:pt idx="4">
                  <c:v>-0.161766818181818</c:v>
                </c:pt>
                <c:pt idx="5">
                  <c:v>-0.286564912280702</c:v>
                </c:pt>
                <c:pt idx="6">
                  <c:v>-0.1998079545454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0029336"/>
        <c:axId val="-2123044152"/>
      </c:barChart>
      <c:catAx>
        <c:axId val="-2100029336"/>
        <c:scaling>
          <c:orientation val="minMax"/>
        </c:scaling>
        <c:delete val="0"/>
        <c:axPos val="b"/>
        <c:majorTickMark val="out"/>
        <c:minorTickMark val="none"/>
        <c:tickLblPos val="low"/>
        <c:txPr>
          <a:bodyPr rot="-5400000" vert="horz"/>
          <a:lstStyle/>
          <a:p>
            <a:pPr>
              <a:defRPr/>
            </a:pPr>
            <a:endParaRPr lang="en-US"/>
          </a:p>
        </c:txPr>
        <c:crossAx val="-2123044152"/>
        <c:crosses val="autoZero"/>
        <c:auto val="1"/>
        <c:lblAlgn val="ctr"/>
        <c:lblOffset val="100"/>
        <c:noMultiLvlLbl val="0"/>
      </c:catAx>
      <c:valAx>
        <c:axId val="-2123044152"/>
        <c:scaling>
          <c:orientation val="minMax"/>
          <c:min val="-0.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ubtracted CI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0002933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82772998030931"/>
          <c:y val="0.506479053512438"/>
          <c:w val="0.0892090678095655"/>
          <c:h val="0.17004441285671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340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8117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92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331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5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331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872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980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089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306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363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459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98083" y="280070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Figure S8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395143" y="62462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386007" y="4859710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B</a:t>
            </a: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9471464"/>
              </p:ext>
            </p:extLst>
          </p:nvPr>
        </p:nvGraphicFramePr>
        <p:xfrm>
          <a:off x="1747152" y="5061780"/>
          <a:ext cx="3240470" cy="28022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5" name="Right Bracket 24"/>
          <p:cNvSpPr/>
          <p:nvPr/>
        </p:nvSpPr>
        <p:spPr>
          <a:xfrm>
            <a:off x="2451865" y="5489967"/>
            <a:ext cx="45719" cy="6090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409507" y="5495244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317939" y="5374437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669719" y="5503097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779783" y="6005019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041964" y="5779237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778058" y="6527184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140527" y="6380669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246609" y="5871569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4507701" y="6094949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396551" y="5145976"/>
            <a:ext cx="60467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begin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396552" y="5375629"/>
            <a:ext cx="60467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end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4396552" y="5603645"/>
            <a:ext cx="60467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test</a:t>
            </a:r>
            <a:endParaRPr lang="en-US" sz="1000" baseline="-25000" dirty="0">
              <a:latin typeface="Arial"/>
              <a:cs typeface="Arial"/>
            </a:endParaRPr>
          </a:p>
        </p:txBody>
      </p:sp>
      <p:graphicFrame>
        <p:nvGraphicFramePr>
          <p:cNvPr id="51" name="Table 5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9179413"/>
              </p:ext>
            </p:extLst>
          </p:nvPr>
        </p:nvGraphicFramePr>
        <p:xfrm>
          <a:off x="2346182" y="3465178"/>
          <a:ext cx="2553418" cy="1112570"/>
        </p:xfrm>
        <a:graphic>
          <a:graphicData uri="http://schemas.openxmlformats.org/drawingml/2006/table">
            <a:tbl>
              <a:tblPr/>
              <a:tblGrid>
                <a:gridCol w="364774"/>
                <a:gridCol w="364774"/>
                <a:gridCol w="364774"/>
                <a:gridCol w="364774"/>
                <a:gridCol w="364774"/>
                <a:gridCol w="364774"/>
                <a:gridCol w="364774"/>
              </a:tblGrid>
              <a:tr h="2225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25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99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25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6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25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25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3333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53" name="Chart 5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47985130"/>
              </p:ext>
            </p:extLst>
          </p:nvPr>
        </p:nvGraphicFramePr>
        <p:xfrm>
          <a:off x="1747152" y="700881"/>
          <a:ext cx="3234016" cy="27595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4" name="TextBox 53"/>
          <p:cNvSpPr txBox="1"/>
          <p:nvPr/>
        </p:nvSpPr>
        <p:spPr>
          <a:xfrm>
            <a:off x="2262127" y="926039"/>
            <a:ext cx="42368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2659052" y="945204"/>
            <a:ext cx="3635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3022597" y="1342326"/>
            <a:ext cx="3635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2395869" y="2202466"/>
            <a:ext cx="3635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2761001" y="2014208"/>
            <a:ext cx="3635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3822178" y="1325760"/>
            <a:ext cx="22337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4118513" y="1296085"/>
            <a:ext cx="3635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4484597" y="1215622"/>
            <a:ext cx="3635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223505" y="2092902"/>
            <a:ext cx="3635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Arial"/>
                <a:cs typeface="Arial"/>
              </a:rPr>
              <a:t>**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63" name="Rectangle 62"/>
          <p:cNvSpPr/>
          <p:nvPr/>
        </p:nvSpPr>
        <p:spPr>
          <a:xfrm>
            <a:off x="2339568" y="925359"/>
            <a:ext cx="363375" cy="3652389"/>
          </a:xfrm>
          <a:prstGeom prst="rect">
            <a:avLst/>
          </a:prstGeom>
          <a:noFill/>
          <a:ln w="19050">
            <a:solidFill>
              <a:srgbClr val="953735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1574842" y="3460389"/>
            <a:ext cx="77648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1000" dirty="0" smtClean="0">
                <a:latin typeface="Arial"/>
                <a:cs typeface="Arial"/>
              </a:rPr>
              <a:t>OA-VPM3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1574842" y="3675893"/>
            <a:ext cx="77648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1000" dirty="0" smtClean="0">
                <a:latin typeface="Arial"/>
                <a:cs typeface="Arial"/>
              </a:rPr>
              <a:t>OA-VPM4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1574842" y="3896382"/>
            <a:ext cx="77648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1000" dirty="0" smtClean="0">
                <a:latin typeface="Arial"/>
                <a:cs typeface="Arial"/>
              </a:rPr>
              <a:t>CSD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1574842" y="4119774"/>
            <a:ext cx="77648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1000" dirty="0" smtClean="0">
                <a:latin typeface="Arial"/>
                <a:cs typeface="Arial"/>
              </a:rPr>
              <a:t>MB-C1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574842" y="4343166"/>
            <a:ext cx="77648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sz="1000" dirty="0" smtClean="0">
                <a:latin typeface="Arial"/>
                <a:cs typeface="Arial"/>
              </a:rPr>
              <a:t>SIF-amide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2706730" y="925359"/>
            <a:ext cx="363375" cy="3652389"/>
          </a:xfrm>
          <a:prstGeom prst="rect">
            <a:avLst/>
          </a:prstGeom>
          <a:noFill/>
          <a:ln w="19050">
            <a:solidFill>
              <a:srgbClr val="953735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52" name="Rectangle 51"/>
          <p:cNvSpPr/>
          <p:nvPr/>
        </p:nvSpPr>
        <p:spPr>
          <a:xfrm>
            <a:off x="4175486" y="925359"/>
            <a:ext cx="363375" cy="3652389"/>
          </a:xfrm>
          <a:prstGeom prst="rect">
            <a:avLst/>
          </a:prstGeom>
          <a:noFill/>
          <a:ln w="19050">
            <a:solidFill>
              <a:srgbClr val="953735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64" name="Right Bracket 63"/>
          <p:cNvSpPr/>
          <p:nvPr/>
        </p:nvSpPr>
        <p:spPr>
          <a:xfrm>
            <a:off x="2546053" y="5610615"/>
            <a:ext cx="45719" cy="6090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65" name="Right Bracket 64"/>
          <p:cNvSpPr/>
          <p:nvPr/>
        </p:nvSpPr>
        <p:spPr>
          <a:xfrm>
            <a:off x="2809585" y="5620131"/>
            <a:ext cx="45719" cy="6090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73" name="Right Bracket 72"/>
          <p:cNvSpPr/>
          <p:nvPr/>
        </p:nvSpPr>
        <p:spPr>
          <a:xfrm>
            <a:off x="2914357" y="6121803"/>
            <a:ext cx="45719" cy="6090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74" name="Right Bracket 73"/>
          <p:cNvSpPr/>
          <p:nvPr/>
        </p:nvSpPr>
        <p:spPr>
          <a:xfrm>
            <a:off x="3177889" y="5893179"/>
            <a:ext cx="45719" cy="6090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75" name="Right Bracket 74"/>
          <p:cNvSpPr/>
          <p:nvPr/>
        </p:nvSpPr>
        <p:spPr>
          <a:xfrm>
            <a:off x="3912409" y="6638283"/>
            <a:ext cx="45719" cy="6090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76" name="Right Bracket 75"/>
          <p:cNvSpPr/>
          <p:nvPr/>
        </p:nvSpPr>
        <p:spPr>
          <a:xfrm>
            <a:off x="4281781" y="6494331"/>
            <a:ext cx="45719" cy="6090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77" name="Right Bracket 76"/>
          <p:cNvSpPr/>
          <p:nvPr/>
        </p:nvSpPr>
        <p:spPr>
          <a:xfrm>
            <a:off x="4381261" y="5985231"/>
            <a:ext cx="45719" cy="6090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78" name="Right Bracket 77"/>
          <p:cNvSpPr/>
          <p:nvPr/>
        </p:nvSpPr>
        <p:spPr>
          <a:xfrm>
            <a:off x="4644793" y="6206427"/>
            <a:ext cx="45719" cy="60907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7743108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72</Words>
  <Application>Microsoft Macintosh PowerPoint</Application>
  <PresentationFormat>Letter Paper (8.5x11 in)</PresentationFormat>
  <Paragraphs>6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lby Montague</dc:creator>
  <cp:lastModifiedBy>Shelby Montague</cp:lastModifiedBy>
  <cp:revision>7</cp:revision>
  <dcterms:created xsi:type="dcterms:W3CDTF">2016-09-29T23:23:19Z</dcterms:created>
  <dcterms:modified xsi:type="dcterms:W3CDTF">2016-09-29T23:25:36Z</dcterms:modified>
</cp:coreProperties>
</file>